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E209FF-B4EA-42FD-B8F4-DEBA974991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DC0670-F207-462A-A321-DE5605CCCC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5454A7-DE8D-4D3B-B6B9-A23BA1F730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2ECA4E-9732-4456-9177-0B66C6242C0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D0B649-21D0-410B-AEE3-0CC8F3995E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8F877-E4EF-40EF-9663-460FE2646B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4EC91E-1A67-44F5-B112-E015BD6426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862A08-A5B1-4540-B8CE-4890209B1A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A2A62C-3E71-4D5B-91DE-10C63E95EA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D5CE16-B664-4925-BBC7-1E175B15F7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EB7B78-1325-43C7-8361-5FC2A408D9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B49DDF-4AA9-42B6-96A7-59DBECBAAB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06A07E-5285-4F84-A299-0ABB8B8C227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04920" y="1828800"/>
          <a:ext cx="8459640" cy="2546280"/>
        </p:xfrm>
        <a:graphic>
          <a:graphicData uri="http://schemas.openxmlformats.org/drawingml/2006/table">
            <a:tbl>
              <a:tblPr/>
              <a:tblGrid>
                <a:gridCol w="1493640"/>
                <a:gridCol w="1049400"/>
                <a:gridCol w="1049400"/>
                <a:gridCol w="1098360"/>
                <a:gridCol w="1032120"/>
                <a:gridCol w="911160"/>
                <a:gridCol w="912600"/>
                <a:gridCol w="912960"/>
              </a:tblGrid>
              <a:tr h="39420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Villa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Popul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No. of Sera Tes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No. of Positive Ser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Positive rate (200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(%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b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A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(200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c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45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0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0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21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Wolg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,9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4.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.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.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17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Haseon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,6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1.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.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.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17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Tongj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6,6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7.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06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1,2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3.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.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92"/>
          <p:cNvSpPr/>
          <p:nvPr/>
        </p:nvSpPr>
        <p:spPr>
          <a:xfrm>
            <a:off x="380880" y="1335240"/>
            <a:ext cx="6477120" cy="41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2. Positive rate of fluorescent antibody responses of sera in Gimpo surveyed are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24"/>
          <p:cNvSpPr/>
          <p:nvPr/>
        </p:nvSpPr>
        <p:spPr>
          <a:xfrm>
            <a:off x="1219320" y="4419720"/>
            <a:ext cx="7391160" cy="163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Note.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   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IFAT; Indirect fluorescent antibody test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     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AAPI; Annual antibody positive index determined by IF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API; Annual parasite index of 2005 and 200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* Significant between AAPI and positive rate of IFAT was analyzed by Two-way ANOVA (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 =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0.7354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#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Significant between API  and positive rate of IFAT was analyzed by Two-way ANOVA (2005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7354, 2006;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7046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&amp;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Significant between API  and AAPI was analyzed by Two-way ANOVA (2005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4388, 2006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0097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8T01:57:40Z</dcterms:created>
  <dc:creator>Lee</dc:creator>
  <dc:description/>
  <dc:language>en-US</dc:language>
  <cp:lastModifiedBy>Marcel Hommel</cp:lastModifiedBy>
  <dcterms:modified xsi:type="dcterms:W3CDTF">2012-07-22T10:27:47Z</dcterms:modified>
  <cp:revision>4</cp:revision>
  <dc:subject/>
  <dc:title>Slide 1</dc:title>
</cp:coreProperties>
</file>